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1BDA1E-A550-4E52-A52F-04ECCA3C09D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2B7C47-9C9B-4658-9975-42DDB1A4FC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9B1BC-9482-4CFE-85B7-58AFDC57AD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A5954-A2A8-4863-BC5F-A4FF2007672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10CE2-F4BD-448C-8E90-6CDB91A093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B3DB6A-47C0-45C0-9819-F4AE7B0EAE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F9E9C6-0E46-4D8F-ABC6-B6E9B4F4FE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304047-01B5-40D0-AAC4-B73B537567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A3011C-613D-4682-A13F-76FB2257A5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F8FAE5-4A6C-485F-B8D7-E42284DF6C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AEDBE4-0BB4-4B6F-91C2-DA59AD4B56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0E5D4-F0FA-46E2-B614-8CECEDF591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592C97-B029-47A8-B493-DFBF154C64F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4"/>
          <p:cNvSpPr/>
          <p:nvPr/>
        </p:nvSpPr>
        <p:spPr>
          <a:xfrm>
            <a:off x="539640" y="981000"/>
            <a:ext cx="5112000" cy="374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Name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-value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Site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2214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4.10e-07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GCCTGGGGTTA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(2.2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4130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6.99e-07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GCCGCGGG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1627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3.00e-06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GCAGGCGC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1874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5.78e-06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TCCAGGGG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2083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8.33e-06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TCATGGGG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3242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8.33e-06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GCAGGGAC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3842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.03e-05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CCTGAGGG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4695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.63e-05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GCCGAAGCCTA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(2.1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2209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.80e-05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TCCTACGG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4393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.80e-05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GCCGGTGGA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3899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2.48e-05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CCCGCAGCA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0649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2.48e-05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CCACAGGCATA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(2.4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0315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3.61e-05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CCCGGGTGC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0982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3.97e-05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GTCGGGGGTC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5051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4.35e-05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GACTGGGGTC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2426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1.73e-04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CGCAGCGGCTA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(5.3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4881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5.03e-04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AAATCGACTTA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1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(7.7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PA4031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8.66e-04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Courier New"/>
                <a:ea typeface="Courier New"/>
              </a:rPr>
              <a:t>TTCTTCGCCGTT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5668920" y="981000"/>
            <a:ext cx="2303640" cy="1865520"/>
            <a:chOff x="5668920" y="981000"/>
            <a:chExt cx="2303640" cy="1865520"/>
          </a:xfrm>
        </p:grpSpPr>
        <p:pic>
          <p:nvPicPr>
            <p:cNvPr id="43" name="Picture 2" descr=""/>
            <p:cNvPicPr/>
            <p:nvPr/>
          </p:nvPicPr>
          <p:blipFill>
            <a:blip r:embed="rId1">
              <a:lum bright="10000"/>
            </a:blip>
            <a:srcRect l="4785" t="53797" r="47507" b="0"/>
            <a:stretch/>
          </p:blipFill>
          <p:spPr>
            <a:xfrm>
              <a:off x="5668920" y="981000"/>
              <a:ext cx="2159640" cy="1175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44"/>
            <p:cNvSpPr/>
            <p:nvPr/>
          </p:nvSpPr>
          <p:spPr>
            <a:xfrm>
              <a:off x="5756760" y="2205000"/>
              <a:ext cx="2215800" cy="64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I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</a:t>
              </a:r>
              <a:r>
                <a:rPr b="0" lang="el-G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Φ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0.3    0.6   1.0   2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4881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5" name="Picture 2" descr=""/>
          <p:cNvPicPr/>
          <p:nvPr/>
        </p:nvPicPr>
        <p:blipFill>
          <a:blip r:embed="rId2"/>
          <a:srcRect l="7527" t="22232" r="66110" b="27783"/>
          <a:stretch/>
        </p:blipFill>
        <p:spPr>
          <a:xfrm>
            <a:off x="6388200" y="3575160"/>
            <a:ext cx="1079280" cy="1296720"/>
          </a:xfrm>
          <a:prstGeom prst="rect">
            <a:avLst/>
          </a:prstGeom>
          <a:ln w="0">
            <a:noFill/>
          </a:ln>
        </p:spPr>
      </p:pic>
      <p:sp>
        <p:nvSpPr>
          <p:cNvPr id="46" name="TextBox 44"/>
          <p:cNvSpPr/>
          <p:nvPr/>
        </p:nvSpPr>
        <p:spPr>
          <a:xfrm>
            <a:off x="5884920" y="4727520"/>
            <a:ext cx="22161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   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rial"/>
              </a:rPr>
              <a:t>Φ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  1.0   2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A187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6090120" y="692280"/>
            <a:ext cx="1759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Arial"/>
              </a:rPr>
              <a:t>1      2       3      4      5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6465600" y="3716280"/>
            <a:ext cx="111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Arial"/>
              </a:rPr>
              <a:t>1      2       3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44"/>
          <p:cNvSpPr/>
          <p:nvPr/>
        </p:nvSpPr>
        <p:spPr>
          <a:xfrm>
            <a:off x="7887600" y="2205000"/>
            <a:ext cx="102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Arial"/>
                <a:ea typeface="Arial"/>
              </a:rPr>
              <a:t>Protein (µ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44"/>
          <p:cNvSpPr/>
          <p:nvPr/>
        </p:nvSpPr>
        <p:spPr>
          <a:xfrm>
            <a:off x="7887600" y="4724280"/>
            <a:ext cx="1023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Arial"/>
                <a:ea typeface="Arial"/>
              </a:rPr>
              <a:t>Protein (µ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3"/>
          <p:cNvSpPr/>
          <p:nvPr/>
        </p:nvSpPr>
        <p:spPr>
          <a:xfrm>
            <a:off x="5292720" y="260280"/>
            <a:ext cx="3743280" cy="590544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44"/>
          <p:cNvSpPr/>
          <p:nvPr/>
        </p:nvSpPr>
        <p:spPr>
          <a:xfrm>
            <a:off x="8098560" y="919080"/>
            <a:ext cx="503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Arial"/>
                <a:ea typeface="Arial"/>
              </a:rPr>
              <a:t>C2/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44"/>
          <p:cNvSpPr/>
          <p:nvPr/>
        </p:nvSpPr>
        <p:spPr>
          <a:xfrm>
            <a:off x="8102880" y="1052640"/>
            <a:ext cx="37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200" spc="-1" strike="noStrike">
                <a:solidFill>
                  <a:srgbClr val="000000"/>
                </a:solidFill>
                <a:latin typeface="Arial"/>
                <a:ea typeface="Arial"/>
              </a:rPr>
              <a:t>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4" name="Straight Arrow Connector 17"/>
          <p:cNvCxnSpPr/>
          <p:nvPr/>
        </p:nvCxnSpPr>
        <p:spPr>
          <a:xfrm flipH="1">
            <a:off x="7380000" y="1190160"/>
            <a:ext cx="7214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5" name="Straight Arrow Connector 18"/>
          <p:cNvCxnSpPr/>
          <p:nvPr/>
        </p:nvCxnSpPr>
        <p:spPr>
          <a:xfrm flipH="1">
            <a:off x="7848360" y="1052280"/>
            <a:ext cx="288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05T09:47:49Z</dcterms:created>
  <dc:creator>lab 441</dc:creator>
  <dc:description/>
  <dc:language>en-US</dc:language>
  <cp:lastModifiedBy>lab 441</cp:lastModifiedBy>
  <dcterms:modified xsi:type="dcterms:W3CDTF">2012-11-05T10:36:28Z</dcterms:modified>
  <cp:revision>4</cp:revision>
  <dc:subject/>
  <dc:title>Slide 1</dc:title>
</cp:coreProperties>
</file>